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7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엄 경현" userId="006d52b91ace3e0e" providerId="LiveId" clId="{A2D64268-2EAE-4743-9BE7-DF8A774300BE}"/>
    <pc:docChg chg="modSld">
      <pc:chgData name="엄 경현" userId="006d52b91ace3e0e" providerId="LiveId" clId="{A2D64268-2EAE-4743-9BE7-DF8A774300BE}" dt="2023-05-17T23:59:10.669" v="2" actId="1076"/>
      <pc:docMkLst>
        <pc:docMk/>
      </pc:docMkLst>
      <pc:sldChg chg="modSp mod">
        <pc:chgData name="엄 경현" userId="006d52b91ace3e0e" providerId="LiveId" clId="{A2D64268-2EAE-4743-9BE7-DF8A774300BE}" dt="2023-05-17T23:59:10.669" v="2" actId="1076"/>
        <pc:sldMkLst>
          <pc:docMk/>
          <pc:sldMk cId="4292007675" sldId="269"/>
        </pc:sldMkLst>
        <pc:spChg chg="mod">
          <ac:chgData name="엄 경현" userId="006d52b91ace3e0e" providerId="LiveId" clId="{A2D64268-2EAE-4743-9BE7-DF8A774300BE}" dt="2023-05-17T23:59:10.669" v="2" actId="1076"/>
          <ac:spMkLst>
            <pc:docMk/>
            <pc:sldMk cId="4292007675" sldId="269"/>
            <ac:spMk id="3" creationId="{4729C250-A997-DA4A-C194-B945381EF65E}"/>
          </ac:spMkLst>
        </pc:spChg>
        <pc:graphicFrameChg chg="mod">
          <ac:chgData name="엄 경현" userId="006d52b91ace3e0e" providerId="LiveId" clId="{A2D64268-2EAE-4743-9BE7-DF8A774300BE}" dt="2023-05-17T23:59:10.669" v="2" actId="1076"/>
          <ac:graphicFrameMkLst>
            <pc:docMk/>
            <pc:sldMk cId="4292007675" sldId="269"/>
            <ac:graphicFrameMk id="7" creationId="{ACEE3C58-5E13-2518-8AB7-C4A1C779702D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193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848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7829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9384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0681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9909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38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223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183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9334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706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E6F10-7102-4C4E-839B-F56F7219CF83}" type="datetimeFigureOut">
              <a:rPr lang="ko-KR" altLang="en-US" smtClean="0"/>
              <a:t>2023-05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9CA4B-8E52-45F8-9425-BD21CA41AE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961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ACEE3C58-5E13-2518-8AB7-C4A1C77970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5659012"/>
              </p:ext>
            </p:extLst>
          </p:nvPr>
        </p:nvGraphicFramePr>
        <p:xfrm>
          <a:off x="630658" y="656583"/>
          <a:ext cx="7519649" cy="53644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79062">
                  <a:extLst>
                    <a:ext uri="{9D8B030D-6E8A-4147-A177-3AD203B41FA5}">
                      <a16:colId xmlns:a16="http://schemas.microsoft.com/office/drawing/2014/main" val="876752776"/>
                    </a:ext>
                  </a:extLst>
                </a:gridCol>
                <a:gridCol w="839880">
                  <a:extLst>
                    <a:ext uri="{9D8B030D-6E8A-4147-A177-3AD203B41FA5}">
                      <a16:colId xmlns:a16="http://schemas.microsoft.com/office/drawing/2014/main" val="1977822907"/>
                    </a:ext>
                  </a:extLst>
                </a:gridCol>
                <a:gridCol w="839880">
                  <a:extLst>
                    <a:ext uri="{9D8B030D-6E8A-4147-A177-3AD203B41FA5}">
                      <a16:colId xmlns:a16="http://schemas.microsoft.com/office/drawing/2014/main" val="1871856476"/>
                    </a:ext>
                  </a:extLst>
                </a:gridCol>
                <a:gridCol w="839880">
                  <a:extLst>
                    <a:ext uri="{9D8B030D-6E8A-4147-A177-3AD203B41FA5}">
                      <a16:colId xmlns:a16="http://schemas.microsoft.com/office/drawing/2014/main" val="3551986810"/>
                    </a:ext>
                  </a:extLst>
                </a:gridCol>
                <a:gridCol w="1001396">
                  <a:extLst>
                    <a:ext uri="{9D8B030D-6E8A-4147-A177-3AD203B41FA5}">
                      <a16:colId xmlns:a16="http://schemas.microsoft.com/office/drawing/2014/main" val="481298821"/>
                    </a:ext>
                  </a:extLst>
                </a:gridCol>
                <a:gridCol w="1469793">
                  <a:extLst>
                    <a:ext uri="{9D8B030D-6E8A-4147-A177-3AD203B41FA5}">
                      <a16:colId xmlns:a16="http://schemas.microsoft.com/office/drawing/2014/main" val="415199782"/>
                    </a:ext>
                  </a:extLst>
                </a:gridCol>
                <a:gridCol w="1349758">
                  <a:extLst>
                    <a:ext uri="{9D8B030D-6E8A-4147-A177-3AD203B41FA5}">
                      <a16:colId xmlns:a16="http://schemas.microsoft.com/office/drawing/2014/main" val="409785923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Offspring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399597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lood items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1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6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9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#10</a:t>
                      </a:r>
                    </a:p>
                  </a:txBody>
                  <a:tcPr marL="45720" marR="4572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ference Range</a:t>
                      </a:r>
                      <a:endParaRPr lang="en-US" altLang="ko-KR" sz="10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Unit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68414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410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450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050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090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140-14180</a:t>
                      </a: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580791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4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6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4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2-142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00/</a:t>
                      </a:r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411002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5-17.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3540887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.4-48.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4873640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tele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.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7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9-112.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00/</a:t>
                      </a:r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4058832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-37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/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5891234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-12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/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16143772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-52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/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6390937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U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9-17.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3430326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eatinin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3-2.5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6757575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2-10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2676143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.bi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-0.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40269693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bum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4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6-4.3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479762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prote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2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2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8-9.9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8502337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obul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2-5.8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26055386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7-10.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562968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9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3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-9.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4022211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4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2.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3.5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7.3-144.2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953873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1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8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7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7-10.84</a:t>
                      </a:r>
                    </a:p>
                  </a:txBody>
                  <a:tcPr marL="45720" marR="4572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/>
                </a:tc>
                <a:extLst>
                  <a:ext uri="{0D108BD9-81ED-4DB2-BD59-A6C34878D82A}">
                    <a16:rowId xmlns:a16="http://schemas.microsoft.com/office/drawing/2014/main" val="3398914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5.8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8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1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3.9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2.3-110.8</a:t>
                      </a: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91060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36E1B55-27EF-CFF8-F9CB-CE0489F1691B}"/>
              </a:ext>
            </a:extLst>
          </p:cNvPr>
          <p:cNvSpPr txBox="1"/>
          <p:nvPr/>
        </p:nvSpPr>
        <p:spPr>
          <a:xfrm>
            <a:off x="0" y="0"/>
            <a:ext cx="87809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 dirty="0"/>
              <a:t>Supplementary Table 4. Blood analysis of calves with gene muta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29C250-A997-DA4A-C194-B945381EF65E}"/>
              </a:ext>
            </a:extLst>
          </p:cNvPr>
          <p:cNvSpPr txBox="1"/>
          <p:nvPr/>
        </p:nvSpPr>
        <p:spPr>
          <a:xfrm>
            <a:off x="560189" y="6069027"/>
            <a:ext cx="76605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#1: MSTN/PRNP mutated beef cattle, #6,9,10: MSTN/BLG mutated dairy cattle. Reference ranges were set from 15 health cattle from same farm.</a:t>
            </a:r>
          </a:p>
        </p:txBody>
      </p:sp>
    </p:spTree>
    <p:extLst>
      <p:ext uri="{BB962C8B-B14F-4D97-AF65-F5344CB8AC3E}">
        <p14:creationId xmlns:p14="http://schemas.microsoft.com/office/powerpoint/2010/main" val="4292007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37</Words>
  <Application>Microsoft Office PowerPoint</Application>
  <PresentationFormat>화면 슬라이드 쇼(4:3)</PresentationFormat>
  <Paragraphs>15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엄 경현</dc:creator>
  <cp:lastModifiedBy>엄 경현</cp:lastModifiedBy>
  <cp:revision>1</cp:revision>
  <dcterms:created xsi:type="dcterms:W3CDTF">2023-04-14T10:57:58Z</dcterms:created>
  <dcterms:modified xsi:type="dcterms:W3CDTF">2023-05-17T23:59:11Z</dcterms:modified>
</cp:coreProperties>
</file>